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  <p:sldId id="262" r:id="rId4"/>
    <p:sldId id="261" r:id="rId5"/>
    <p:sldId id="263" r:id="rId6"/>
    <p:sldId id="258" r:id="rId7"/>
    <p:sldId id="268" r:id="rId8"/>
    <p:sldId id="257" r:id="rId9"/>
    <p:sldId id="264" r:id="rId10"/>
    <p:sldId id="256" r:id="rId11"/>
    <p:sldId id="269" r:id="rId12"/>
    <p:sldId id="271" r:id="rId13"/>
    <p:sldId id="266" r:id="rId14"/>
    <p:sldId id="265" r:id="rId15"/>
    <p:sldId id="275" r:id="rId16"/>
    <p:sldId id="272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707" autoAdjust="0"/>
  </p:normalViewPr>
  <p:slideViewPr>
    <p:cSldViewPr snapToGrid="0" showGuides="1">
      <p:cViewPr varScale="1">
        <p:scale>
          <a:sx n="106" d="100"/>
          <a:sy n="106" d="100"/>
        </p:scale>
        <p:origin x="654" y="114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-258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73828-4164-415C-8C75-D77755AE4382}" type="datetimeFigureOut">
              <a:rPr lang="en-AU" smtClean="0"/>
              <a:t>12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8D9AE-CA12-4FA2-B436-D6A7A6AD8A1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82210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73828-4164-415C-8C75-D77755AE4382}" type="datetimeFigureOut">
              <a:rPr lang="en-AU" smtClean="0"/>
              <a:t>12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8D9AE-CA12-4FA2-B436-D6A7A6AD8A1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421239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73828-4164-415C-8C75-D77755AE4382}" type="datetimeFigureOut">
              <a:rPr lang="en-AU" smtClean="0"/>
              <a:t>12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8D9AE-CA12-4FA2-B436-D6A7A6AD8A1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563291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73828-4164-415C-8C75-D77755AE4382}" type="datetimeFigureOut">
              <a:rPr lang="en-AU" smtClean="0"/>
              <a:t>12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8D9AE-CA12-4FA2-B436-D6A7A6AD8A1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341730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73828-4164-415C-8C75-D77755AE4382}" type="datetimeFigureOut">
              <a:rPr lang="en-AU" smtClean="0"/>
              <a:t>12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8D9AE-CA12-4FA2-B436-D6A7A6AD8A1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89321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73828-4164-415C-8C75-D77755AE4382}" type="datetimeFigureOut">
              <a:rPr lang="en-AU" smtClean="0"/>
              <a:t>12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8D9AE-CA12-4FA2-B436-D6A7A6AD8A1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183019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73828-4164-415C-8C75-D77755AE4382}" type="datetimeFigureOut">
              <a:rPr lang="en-AU" smtClean="0"/>
              <a:t>12/11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8D9AE-CA12-4FA2-B436-D6A7A6AD8A1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844164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73828-4164-415C-8C75-D77755AE4382}" type="datetimeFigureOut">
              <a:rPr lang="en-AU" smtClean="0"/>
              <a:t>12/11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8D9AE-CA12-4FA2-B436-D6A7A6AD8A1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977074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73828-4164-415C-8C75-D77755AE4382}" type="datetimeFigureOut">
              <a:rPr lang="en-AU" smtClean="0"/>
              <a:t>12/11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8D9AE-CA12-4FA2-B436-D6A7A6AD8A1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759975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73828-4164-415C-8C75-D77755AE4382}" type="datetimeFigureOut">
              <a:rPr lang="en-AU" smtClean="0"/>
              <a:t>12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8D9AE-CA12-4FA2-B436-D6A7A6AD8A1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252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C73828-4164-415C-8C75-D77755AE4382}" type="datetimeFigureOut">
              <a:rPr lang="en-AU" smtClean="0"/>
              <a:t>12/11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38D9AE-CA12-4FA2-B436-D6A7A6AD8A1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074830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C73828-4164-415C-8C75-D77755AE4382}" type="datetimeFigureOut">
              <a:rPr lang="en-AU" smtClean="0"/>
              <a:t>12/11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38D9AE-CA12-4FA2-B436-D6A7A6AD8A1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255238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69" y="0"/>
            <a:ext cx="1207091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8148909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8976" y="0"/>
            <a:ext cx="481404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374927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4135" y="118479"/>
            <a:ext cx="8357198" cy="65206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253988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4518" y="-9054"/>
            <a:ext cx="6085182" cy="68650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3139716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4190" y="0"/>
            <a:ext cx="932766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408530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7840" y="0"/>
            <a:ext cx="695005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458769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4849" y="-2179"/>
            <a:ext cx="8588188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716367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6800" y="108374"/>
            <a:ext cx="10058400" cy="68173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58733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58" y="0"/>
            <a:ext cx="1208882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44727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260" y="0"/>
            <a:ext cx="1029817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89735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2059" y="0"/>
            <a:ext cx="748788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585056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1976" y="81940"/>
            <a:ext cx="7159292" cy="66408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1044312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7367" y="0"/>
            <a:ext cx="9699401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73010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7505" y="239597"/>
            <a:ext cx="8447964" cy="63788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96212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7146" y="10962"/>
            <a:ext cx="756210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066982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6284" y="0"/>
            <a:ext cx="979157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031442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18</TotalTime>
  <Words>0</Words>
  <Application>Microsoft Office PowerPoint</Application>
  <PresentationFormat>Widescreen</PresentationFormat>
  <Paragraphs>0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Queensland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rimalan Rangan</dc:creator>
  <cp:lastModifiedBy>Parimalan Rangan</cp:lastModifiedBy>
  <cp:revision>27</cp:revision>
  <dcterms:created xsi:type="dcterms:W3CDTF">2015-05-28T00:03:23Z</dcterms:created>
  <dcterms:modified xsi:type="dcterms:W3CDTF">2015-11-12T08:48:39Z</dcterms:modified>
</cp:coreProperties>
</file>